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prostate</a:t>
            </a:r>
            <a:r>
              <a:rPr lang="en-US" baseline="0"/>
              <a:t> cancer</a:t>
            </a:r>
            <a:endParaRPr lang="en-US"/>
          </a:p>
        </c:rich>
      </c:tx>
      <c:layout>
        <c:manualLayout>
          <c:xMode val="edge"/>
          <c:yMode val="edge"/>
          <c:x val="0.20579155730533683"/>
          <c:y val="2.77777777777777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2811351706036744"/>
          <c:y val="0.1299886993292505"/>
          <c:w val="0.4996049868766404"/>
          <c:h val="0.71141550014581512"/>
        </c:manualLayout>
      </c:layout>
      <c:scatterChart>
        <c:scatterStyle val="smoothMarker"/>
        <c:varyColors val="0"/>
        <c:ser>
          <c:idx val="1"/>
          <c:order val="1"/>
          <c:tx>
            <c:strRef>
              <c:f>Sheet6!$G$7</c:f>
              <c:strCache>
                <c:ptCount val="1"/>
                <c:pt idx="0">
                  <c:v>TK1 protein (A.U)</c:v>
                </c:pt>
              </c:strCache>
            </c:strRef>
          </c:tx>
          <c:xVal>
            <c:numRef>
              <c:f>Sheet6!$E$8:$E$18</c:f>
              <c:numCache>
                <c:formatCode>General</c:formatCode>
                <c:ptCount val="11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</c:numCache>
            </c:numRef>
          </c:xVal>
          <c:yVal>
            <c:numRef>
              <c:f>Sheet6!$G$8:$G$18</c:f>
              <c:numCache>
                <c:formatCode>General</c:formatCode>
                <c:ptCount val="11"/>
                <c:pt idx="0">
                  <c:v>2</c:v>
                </c:pt>
                <c:pt idx="1">
                  <c:v>2</c:v>
                </c:pt>
                <c:pt idx="2">
                  <c:v>7</c:v>
                </c:pt>
                <c:pt idx="3">
                  <c:v>38</c:v>
                </c:pt>
                <c:pt idx="4">
                  <c:v>75</c:v>
                </c:pt>
                <c:pt idx="5">
                  <c:v>70</c:v>
                </c:pt>
                <c:pt idx="6">
                  <c:v>52</c:v>
                </c:pt>
                <c:pt idx="7">
                  <c:v>12</c:v>
                </c:pt>
                <c:pt idx="8">
                  <c:v>3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060416"/>
        <c:axId val="38025088"/>
      </c:scatterChart>
      <c:scatterChart>
        <c:scatterStyle val="smoothMarker"/>
        <c:varyColors val="0"/>
        <c:ser>
          <c:idx val="0"/>
          <c:order val="0"/>
          <c:tx>
            <c:strRef>
              <c:f>Sheet6!$F$7</c:f>
              <c:strCache>
                <c:ptCount val="1"/>
                <c:pt idx="0">
                  <c:v>TK1 activity</c:v>
                </c:pt>
              </c:strCache>
            </c:strRef>
          </c:tx>
          <c:xVal>
            <c:numRef>
              <c:f>Sheet6!$E$8:$E$18</c:f>
              <c:numCache>
                <c:formatCode>General</c:formatCode>
                <c:ptCount val="11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</c:numCache>
            </c:numRef>
          </c:xVal>
          <c:yVal>
            <c:numRef>
              <c:f>Sheet6!$F$8:$F$18</c:f>
              <c:numCache>
                <c:formatCode>General</c:formatCode>
                <c:ptCount val="11"/>
                <c:pt idx="0">
                  <c:v>6.4000000000000001E-2</c:v>
                </c:pt>
                <c:pt idx="1">
                  <c:v>0.107</c:v>
                </c:pt>
                <c:pt idx="2">
                  <c:v>0.1</c:v>
                </c:pt>
                <c:pt idx="3">
                  <c:v>0.124</c:v>
                </c:pt>
                <c:pt idx="4">
                  <c:v>0.104</c:v>
                </c:pt>
                <c:pt idx="5">
                  <c:v>4.2999999999999997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025472"/>
        <c:axId val="38062336"/>
      </c:scatterChart>
      <c:valAx>
        <c:axId val="380604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rcations no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025088"/>
        <c:crosses val="autoZero"/>
        <c:crossBetween val="midCat"/>
      </c:valAx>
      <c:valAx>
        <c:axId val="38025088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TK1 protein (A.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060416"/>
        <c:crosses val="autoZero"/>
        <c:crossBetween val="midCat"/>
      </c:valAx>
      <c:valAx>
        <c:axId val="38062336"/>
        <c:scaling>
          <c:orientation val="minMax"/>
          <c:min val="0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TK1 activity (pmol/min/m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025472"/>
        <c:crosses val="max"/>
        <c:crossBetween val="midCat"/>
      </c:valAx>
      <c:valAx>
        <c:axId val="380254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80623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0740157480314958"/>
          <c:y val="2.9650772820064186E-2"/>
          <c:w val="0.27870953630796153"/>
          <c:h val="0.1674343832020997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reast cancer</a:t>
            </a:r>
          </a:p>
        </c:rich>
      </c:tx>
      <c:layout>
        <c:manualLayout>
          <c:xMode val="edge"/>
          <c:yMode val="edge"/>
          <c:x val="0.2965485564304462"/>
          <c:y val="4.629621256552889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978018372703409"/>
          <c:y val="0.16438257506271914"/>
          <c:w val="0.44146609798775149"/>
          <c:h val="0.67870333528832716"/>
        </c:manualLayout>
      </c:layout>
      <c:scatterChart>
        <c:scatterStyle val="smoothMarker"/>
        <c:varyColors val="0"/>
        <c:ser>
          <c:idx val="1"/>
          <c:order val="1"/>
          <c:tx>
            <c:strRef>
              <c:f>Sheet6!$L$7</c:f>
              <c:strCache>
                <c:ptCount val="1"/>
                <c:pt idx="0">
                  <c:v>TK1 protein (A.U)</c:v>
                </c:pt>
              </c:strCache>
            </c:strRef>
          </c:tx>
          <c:xVal>
            <c:numRef>
              <c:f>Sheet6!$J$8:$J$18</c:f>
              <c:numCache>
                <c:formatCode>General</c:formatCode>
                <c:ptCount val="11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</c:numCache>
            </c:numRef>
          </c:xVal>
          <c:yVal>
            <c:numRef>
              <c:f>Sheet6!$L$8:$L$18</c:f>
              <c:numCache>
                <c:formatCode>General</c:formatCode>
                <c:ptCount val="11"/>
                <c:pt idx="0">
                  <c:v>25</c:v>
                </c:pt>
                <c:pt idx="1">
                  <c:v>20</c:v>
                </c:pt>
                <c:pt idx="2">
                  <c:v>12</c:v>
                </c:pt>
                <c:pt idx="3">
                  <c:v>28</c:v>
                </c:pt>
                <c:pt idx="4">
                  <c:v>30</c:v>
                </c:pt>
                <c:pt idx="5">
                  <c:v>18</c:v>
                </c:pt>
                <c:pt idx="6">
                  <c:v>30</c:v>
                </c:pt>
                <c:pt idx="7">
                  <c:v>25</c:v>
                </c:pt>
                <c:pt idx="8">
                  <c:v>30</c:v>
                </c:pt>
                <c:pt idx="9">
                  <c:v>22</c:v>
                </c:pt>
                <c:pt idx="10">
                  <c:v>1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191488"/>
        <c:axId val="38193408"/>
      </c:scatterChart>
      <c:scatterChart>
        <c:scatterStyle val="smoothMarker"/>
        <c:varyColors val="0"/>
        <c:ser>
          <c:idx val="0"/>
          <c:order val="0"/>
          <c:tx>
            <c:strRef>
              <c:f>Sheet6!$K$7</c:f>
              <c:strCache>
                <c:ptCount val="1"/>
                <c:pt idx="0">
                  <c:v>TK1 activity</c:v>
                </c:pt>
              </c:strCache>
            </c:strRef>
          </c:tx>
          <c:xVal>
            <c:numRef>
              <c:f>Sheet6!$J$8:$J$18</c:f>
              <c:numCache>
                <c:formatCode>General</c:formatCode>
                <c:ptCount val="11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</c:numCache>
            </c:numRef>
          </c:xVal>
          <c:yVal>
            <c:numRef>
              <c:f>Sheet6!$K$8:$K$18</c:f>
              <c:numCache>
                <c:formatCode>General</c:formatCode>
                <c:ptCount val="11"/>
                <c:pt idx="0">
                  <c:v>0.24</c:v>
                </c:pt>
                <c:pt idx="1">
                  <c:v>0.47</c:v>
                </c:pt>
                <c:pt idx="2">
                  <c:v>0.5</c:v>
                </c:pt>
                <c:pt idx="3">
                  <c:v>0.18</c:v>
                </c:pt>
                <c:pt idx="4">
                  <c:v>0.04</c:v>
                </c:pt>
                <c:pt idx="5">
                  <c:v>0</c:v>
                </c:pt>
                <c:pt idx="6">
                  <c:v>0.13</c:v>
                </c:pt>
                <c:pt idx="7">
                  <c:v>0</c:v>
                </c:pt>
                <c:pt idx="8">
                  <c:v>0.02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87616"/>
        <c:axId val="38285696"/>
      </c:scatterChart>
      <c:valAx>
        <c:axId val="381914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rcations no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193408"/>
        <c:crosses val="autoZero"/>
        <c:crossBetween val="midCat"/>
      </c:valAx>
      <c:valAx>
        <c:axId val="381934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TK1 protein (A.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191488"/>
        <c:crosses val="autoZero"/>
        <c:crossBetween val="midCat"/>
      </c:valAx>
      <c:valAx>
        <c:axId val="38285696"/>
        <c:scaling>
          <c:orientation val="minMax"/>
          <c:min val="0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TK1 activity (pmol/min/m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287616"/>
        <c:crosses val="max"/>
        <c:crossBetween val="midCat"/>
      </c:valAx>
      <c:valAx>
        <c:axId val="382876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82856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2129046369203853"/>
          <c:y val="6.6888562769511412E-2"/>
          <c:w val="0.27870953630796153"/>
          <c:h val="0.1483381691439969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DS</a:t>
            </a:r>
          </a:p>
        </c:rich>
      </c:tx>
      <c:layout>
        <c:manualLayout>
          <c:xMode val="edge"/>
          <c:yMode val="edge"/>
          <c:x val="0.31446522309711283"/>
          <c:y val="5.064494096615527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419072615923"/>
          <c:y val="0.1794503893506782"/>
          <c:w val="0.455160542432196"/>
          <c:h val="0.6631961978972033"/>
        </c:manualLayout>
      </c:layout>
      <c:scatterChart>
        <c:scatterStyle val="smoothMarker"/>
        <c:varyColors val="0"/>
        <c:ser>
          <c:idx val="1"/>
          <c:order val="1"/>
          <c:tx>
            <c:strRef>
              <c:f>Sheet6!$Y$7</c:f>
              <c:strCache>
                <c:ptCount val="1"/>
                <c:pt idx="0">
                  <c:v>TK1 protein (A.U)</c:v>
                </c:pt>
              </c:strCache>
            </c:strRef>
          </c:tx>
          <c:xVal>
            <c:numRef>
              <c:f>Sheet6!$W$8:$W$18</c:f>
              <c:numCache>
                <c:formatCode>General</c:formatCode>
                <c:ptCount val="11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</c:numCache>
            </c:numRef>
          </c:xVal>
          <c:yVal>
            <c:numRef>
              <c:f>Sheet6!$Y$8:$Y$18</c:f>
              <c:numCache>
                <c:formatCode>General</c:formatCode>
                <c:ptCount val="11"/>
                <c:pt idx="0">
                  <c:v>52</c:v>
                </c:pt>
                <c:pt idx="1">
                  <c:v>48</c:v>
                </c:pt>
                <c:pt idx="2">
                  <c:v>15</c:v>
                </c:pt>
                <c:pt idx="3">
                  <c:v>9</c:v>
                </c:pt>
                <c:pt idx="4">
                  <c:v>20</c:v>
                </c:pt>
                <c:pt idx="5">
                  <c:v>70</c:v>
                </c:pt>
                <c:pt idx="6">
                  <c:v>102</c:v>
                </c:pt>
                <c:pt idx="7">
                  <c:v>55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34752"/>
        <c:axId val="38241024"/>
      </c:scatterChart>
      <c:scatterChart>
        <c:scatterStyle val="smoothMarker"/>
        <c:varyColors val="0"/>
        <c:ser>
          <c:idx val="0"/>
          <c:order val="0"/>
          <c:tx>
            <c:strRef>
              <c:f>Sheet6!$X$7</c:f>
              <c:strCache>
                <c:ptCount val="1"/>
                <c:pt idx="0">
                  <c:v>TK1 activity</c:v>
                </c:pt>
              </c:strCache>
            </c:strRef>
          </c:tx>
          <c:xVal>
            <c:numRef>
              <c:f>Sheet6!$W$8:$W$18</c:f>
              <c:numCache>
                <c:formatCode>General</c:formatCode>
                <c:ptCount val="11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</c:numCache>
            </c:numRef>
          </c:xVal>
          <c:yVal>
            <c:numRef>
              <c:f>Sheet6!$X$8:$X$18</c:f>
              <c:numCache>
                <c:formatCode>General</c:formatCode>
                <c:ptCount val="11"/>
                <c:pt idx="0">
                  <c:v>0.23</c:v>
                </c:pt>
                <c:pt idx="1">
                  <c:v>0.72</c:v>
                </c:pt>
                <c:pt idx="2">
                  <c:v>0.53</c:v>
                </c:pt>
                <c:pt idx="3">
                  <c:v>0.27</c:v>
                </c:pt>
                <c:pt idx="4">
                  <c:v>0.09</c:v>
                </c:pt>
                <c:pt idx="5">
                  <c:v>0.24</c:v>
                </c:pt>
                <c:pt idx="6">
                  <c:v>0.48899999999999999</c:v>
                </c:pt>
                <c:pt idx="7">
                  <c:v>0.313</c:v>
                </c:pt>
                <c:pt idx="8">
                  <c:v>0.13</c:v>
                </c:pt>
                <c:pt idx="9">
                  <c:v>0.108</c:v>
                </c:pt>
                <c:pt idx="10">
                  <c:v>0.0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49216"/>
        <c:axId val="38242944"/>
      </c:scatterChart>
      <c:valAx>
        <c:axId val="382347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rcations no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241024"/>
        <c:crosses val="autoZero"/>
        <c:crossBetween val="midCat"/>
      </c:valAx>
      <c:valAx>
        <c:axId val="3824102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TK1 protein (A.U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234752"/>
        <c:crosses val="autoZero"/>
        <c:crossBetween val="midCat"/>
      </c:valAx>
      <c:valAx>
        <c:axId val="38242944"/>
        <c:scaling>
          <c:orientation val="minMax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TK1 activity (pmol/min/m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8249216"/>
        <c:crosses val="max"/>
        <c:crossBetween val="midCat"/>
      </c:valAx>
      <c:valAx>
        <c:axId val="382492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824294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6295713035870518"/>
          <c:y val="2.0731913625758758E-2"/>
          <c:w val="0.27870953630796153"/>
          <c:h val="0.1674343832020997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E754C3-3BF8-4D90-BCD2-F0E4D0F7652B}" type="datetimeFigureOut">
              <a:rPr lang="en-US" smtClean="0"/>
              <a:t>11/3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7170FB-9116-494F-A5EA-8A4B26BA6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758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1CBD8C-3C81-41FA-A35C-3A6A8B054A0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5323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A793F2-0BCA-4286-89F1-7BC258CD7EBF}" type="datetime1">
              <a:rPr lang="en-US" smtClean="0"/>
              <a:t>11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235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BCFAE-A6DB-4F40-8520-0713B4786D1E}" type="datetime1">
              <a:rPr lang="en-US" smtClean="0"/>
              <a:t>11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125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8C5F5-C9A6-4B6B-8244-DF1354D6753B}" type="datetime1">
              <a:rPr lang="en-US" smtClean="0"/>
              <a:t>11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43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E9989-A09C-4739-8630-B26ABDC89F41}" type="datetime1">
              <a:rPr lang="en-US" smtClean="0"/>
              <a:t>11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299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EB319-8B77-4397-8B16-39CD6CCEB7F8}" type="datetime1">
              <a:rPr lang="en-US" smtClean="0"/>
              <a:t>11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018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4875F-8F82-49D1-9C6D-E5DF0BC49715}" type="datetime1">
              <a:rPr lang="en-US" smtClean="0"/>
              <a:t>11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664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9EED6-8EF7-40EE-BA7E-648660DF1A98}" type="datetime1">
              <a:rPr lang="en-US" smtClean="0"/>
              <a:t>11/3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198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B2218-36AC-4AEC-8A00-6018CA31EA48}" type="datetime1">
              <a:rPr lang="en-US" smtClean="0"/>
              <a:t>11/3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739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E47D7-7A52-4B04-8408-9848271996C5}" type="datetime1">
              <a:rPr lang="en-US" smtClean="0"/>
              <a:t>11/3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738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C6935-5CC4-4F24-859B-85928E9524AF}" type="datetime1">
              <a:rPr lang="en-US" smtClean="0"/>
              <a:t>11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337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7FEE6-7036-46B5-98BD-6147AD62CC86}" type="datetime1">
              <a:rPr lang="en-US" smtClean="0"/>
              <a:t>11/3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629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CDE9F-E935-41DC-8F3B-2F14436E29FA}" type="datetime1">
              <a:rPr lang="en-US" smtClean="0"/>
              <a:t>11/3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22F30-20FF-4366-BC9A-8B8CB3F31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919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microsoft.com/office/2007/relationships/hdphoto" Target="../media/hdphoto1.wdp"/><Relationship Id="rId7" Type="http://schemas.openxmlformats.org/officeDocument/2006/relationships/image" Target="../media/image9.png"/><Relationship Id="rId12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.png"/><Relationship Id="rId11" Type="http://schemas.openxmlformats.org/officeDocument/2006/relationships/image" Target="../media/image12.png"/><Relationship Id="rId5" Type="http://schemas.openxmlformats.org/officeDocument/2006/relationships/image" Target="../media/image7.png"/><Relationship Id="rId10" Type="http://schemas.openxmlformats.org/officeDocument/2006/relationships/image" Target="../media/image11.png"/><Relationship Id="rId4" Type="http://schemas.openxmlformats.org/officeDocument/2006/relationships/image" Target="../media/image6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14.png"/><Relationship Id="rId7" Type="http://schemas.openxmlformats.org/officeDocument/2006/relationships/image" Target="../media/image18.tif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Kiran\Desktop\Kiran figure (1)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548680"/>
            <a:ext cx="7204282" cy="57961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899592" y="1873944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CNBr sepherose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27784" y="1891379"/>
            <a:ext cx="1277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MAB 526-4  Ab 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050949" y="1168833"/>
            <a:ext cx="14401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Ab coupled with </a:t>
            </a:r>
          </a:p>
          <a:p>
            <a:endParaRPr lang="sv-SE" sz="1200" b="1" dirty="0">
              <a:latin typeface="Arial" pitchFamily="34" charset="0"/>
              <a:cs typeface="Arial" pitchFamily="34" charset="0"/>
            </a:endParaRPr>
          </a:p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Sepherose at 4°C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785932" y="2348880"/>
            <a:ext cx="1296144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Ab coupled Sepherose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771029" y="4027270"/>
            <a:ext cx="1296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Human serum sample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39785" y="2996952"/>
            <a:ext cx="12223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Incubated at</a:t>
            </a:r>
          </a:p>
          <a:p>
            <a:endParaRPr lang="sv-SE" sz="1200" b="1" dirty="0">
              <a:latin typeface="Arial" pitchFamily="34" charset="0"/>
              <a:cs typeface="Arial" pitchFamily="34" charset="0"/>
            </a:endParaRPr>
          </a:p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 4°C for  4 hr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9673975">
            <a:off x="73551" y="2958772"/>
            <a:ext cx="18655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Un specific  bound  proteins are washed 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21235515">
            <a:off x="1788115" y="5381865"/>
            <a:ext cx="1487882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bound  proteins were eluted with Sample buffer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85476" y="5381864"/>
            <a:ext cx="21802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     Analysed by </a:t>
            </a:r>
          </a:p>
          <a:p>
            <a:endParaRPr lang="sv-SE" sz="1200" b="1" dirty="0">
              <a:latin typeface="Arial" pitchFamily="34" charset="0"/>
              <a:cs typeface="Arial" pitchFamily="34" charset="0"/>
            </a:endParaRPr>
          </a:p>
          <a:p>
            <a:r>
              <a:rPr lang="sv-SE" sz="1200" b="1" dirty="0" smtClean="0">
                <a:latin typeface="Arial" pitchFamily="34" charset="0"/>
                <a:cs typeface="Arial" pitchFamily="34" charset="0"/>
              </a:rPr>
              <a:t>    SDS-PAGE gel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758556" y="4997429"/>
            <a:ext cx="16769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tection with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XPA 210 IgY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 flipH="1">
            <a:off x="7959858" y="5695083"/>
            <a:ext cx="663173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7959858" y="5428031"/>
            <a:ext cx="15770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 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23528" y="602659"/>
            <a:ext cx="26642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imentary Figure 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23528" y="188640"/>
            <a:ext cx="33619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imentary Figure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430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C:\Users\Kiran\Desktop\Picture3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960" y="2060848"/>
            <a:ext cx="2803525" cy="517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579783" y="1830016"/>
            <a:ext cx="34250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itchFamily="34" charset="0"/>
                <a:cs typeface="Arial" pitchFamily="34" charset="0"/>
              </a:rPr>
              <a:t>      12    13     14     15      16       17      18     19    20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4" descr="C:\Users\Kiran\Desktop\Picture4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30824" y="2060848"/>
            <a:ext cx="2895600" cy="542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330824" y="1830016"/>
            <a:ext cx="34250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itchFamily="34" charset="0"/>
                <a:cs typeface="Arial" pitchFamily="34" charset="0"/>
              </a:rPr>
              <a:t> 21     22     23     24     25    26      27     28     29    30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6" descr="C:\Users\Kiran\Desktop\Picture6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628" y="4235865"/>
            <a:ext cx="3024187" cy="6334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559923" y="4005033"/>
            <a:ext cx="34250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itchFamily="34" charset="0"/>
                <a:cs typeface="Arial" pitchFamily="34" charset="0"/>
              </a:rPr>
              <a:t> 11  12    13    14    15    16  17    18    19    20     21   22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600758" y="4285801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226424" y="2052537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476883" y="2042611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7226424" y="2332310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H="1">
            <a:off x="3505735" y="2319610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3619815" y="4552571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51520" y="399748"/>
            <a:ext cx="28083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>
                <a:latin typeface="Arial" panose="020B0604020202020204" pitchFamily="34" charset="0"/>
                <a:cs typeface="Arial" panose="020B0604020202020204" pitchFamily="34" charset="0"/>
              </a:rPr>
              <a:t>Supplimentary</a:t>
            </a:r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07503" y="1057577"/>
            <a:ext cx="452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07504" y="3543367"/>
            <a:ext cx="4524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sv-S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Slide Number Placeholder 1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314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8140" y="1211560"/>
            <a:ext cx="2945915" cy="5302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81297" y="980728"/>
            <a:ext cx="31736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      10       11     12     13     14      15    16    17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305" y="2411145"/>
            <a:ext cx="3211048" cy="5778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6569" y="2435696"/>
            <a:ext cx="720132" cy="59396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297" y="1217641"/>
            <a:ext cx="2634983" cy="5000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4768610" y="959841"/>
            <a:ext cx="29249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    19     20     21      22    23     24      25    26      27     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29293" y="2204864"/>
            <a:ext cx="32010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8   29    30    31     32   33    34      35    36     37    38   39   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88144" y="2179638"/>
            <a:ext cx="8638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40   41   42 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3730353" y="2684946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3248755" y="1436725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7693586" y="1404527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H="1">
            <a:off x="5580572" y="2732678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248755" y="1190673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730353" y="2411145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580572" y="2435696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693586" y="1105947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" contras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293" y="3789040"/>
            <a:ext cx="2719462" cy="58635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2" name="Picture 6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9324" y="3832344"/>
            <a:ext cx="2364964" cy="54304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3" name="Picture 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9305" y="5373216"/>
            <a:ext cx="3125494" cy="56816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4" name="Picture 5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4000" contras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9324" y="5373215"/>
            <a:ext cx="1788900" cy="56817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83021" y="205290"/>
            <a:ext cx="35617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imentary</a:t>
            </a:r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71117" y="3558208"/>
            <a:ext cx="31736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0     11     12       13      14     15      16      17   18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758140" y="3558208"/>
            <a:ext cx="29249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9  20   21   22    23  24   25     26  27  28     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81522" y="5116665"/>
            <a:ext cx="32010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9    30    31    32     33    34     35    36   37   38    39   40   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758140" y="5116664"/>
            <a:ext cx="1830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1    42    43   44   45    46    47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 flipH="1">
            <a:off x="7164288" y="4103868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H="1">
            <a:off x="3248755" y="4101032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H="1">
            <a:off x="3644799" y="5657300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flipH="1">
            <a:off x="6588224" y="5657300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7164288" y="3822351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248755" y="3809361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624300" y="5358754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585966" y="5346587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03357" y="731360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8680" y="3264424"/>
            <a:ext cx="3658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1574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365" y="667004"/>
            <a:ext cx="3055085" cy="2132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0072" y="548680"/>
            <a:ext cx="2952328" cy="20266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109" y="3573016"/>
            <a:ext cx="2860766" cy="19970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4088" y="3429000"/>
            <a:ext cx="2664295" cy="1828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8" name="Picture 14" descr="C:\Users\Kiran\Desktop\Picture2.tif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4089" y="2799660"/>
            <a:ext cx="2520280" cy="36512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C:\Users\Kiran\Desktop\Picture3.tif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832" y="2963966"/>
            <a:ext cx="2628149" cy="40163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704780" y="2733134"/>
            <a:ext cx="26330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itchFamily="34" charset="0"/>
                <a:cs typeface="Arial" pitchFamily="34" charset="0"/>
              </a:rPr>
              <a:t>  2    4      6     8   10    12  14  16   18    20   22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97938" y="5502934"/>
            <a:ext cx="26330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itchFamily="34" charset="0"/>
                <a:cs typeface="Arial" pitchFamily="34" charset="0"/>
              </a:rPr>
              <a:t>2    4      6      8   10   12  14  16    18   20   22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307680" y="2575337"/>
            <a:ext cx="26330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900" b="1" dirty="0" smtClean="0">
                <a:latin typeface="Arial" pitchFamily="34" charset="0"/>
                <a:cs typeface="Arial" pitchFamily="34" charset="0"/>
              </a:rPr>
              <a:t>  2    4      6     8   10    12  14  16   18    20   22</a:t>
            </a:r>
            <a:endParaRPr lang="en-US" sz="9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41" name="Picture 17" descr="C:\Users\Kiran\Desktop\Picture5.tif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109" y="5733766"/>
            <a:ext cx="2438400" cy="454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83022" y="205290"/>
            <a:ext cx="38409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600" b="1" dirty="0">
                <a:latin typeface="Arial" panose="020B0604020202020204" pitchFamily="34" charset="0"/>
                <a:cs typeface="Arial" panose="020B0604020202020204" pitchFamily="34" charset="0"/>
              </a:rPr>
              <a:t>Supplimentary</a:t>
            </a:r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3300981" y="3137681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7884369" y="2938951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3261338" y="5950376"/>
            <a:ext cx="50622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304262" y="2860682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261338" y="5683779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884369" y="2690753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40784" y="561593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A)</a:t>
            </a:r>
            <a:endParaRPr lang="en-US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40784" y="2579245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/>
              <a:t>B</a:t>
            </a:r>
            <a:r>
              <a:rPr lang="sv-SE" sz="1400" b="1" dirty="0" smtClean="0"/>
              <a:t>)</a:t>
            </a:r>
            <a:endParaRPr lang="en-US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72732" y="3570118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/>
              <a:t>C</a:t>
            </a:r>
            <a:r>
              <a:rPr lang="sv-SE" sz="1400" b="1" dirty="0" smtClean="0"/>
              <a:t>)</a:t>
            </a:r>
            <a:endParaRPr lang="en-US" sz="1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310623" y="5262247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/>
              <a:t>D</a:t>
            </a:r>
            <a:r>
              <a:rPr lang="sv-SE" sz="1400" b="1" dirty="0" smtClean="0"/>
              <a:t>)</a:t>
            </a:r>
            <a:endParaRPr lang="en-US" sz="14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767475" y="389955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/>
              <a:t>E</a:t>
            </a:r>
            <a:r>
              <a:rPr lang="sv-SE" sz="1400" b="1" dirty="0" smtClean="0"/>
              <a:t>)</a:t>
            </a:r>
            <a:endParaRPr lang="en-US" sz="14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788024" y="2491883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F)</a:t>
            </a:r>
            <a:endParaRPr lang="en-US" sz="14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779340" y="3395092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G)</a:t>
            </a:r>
            <a:endParaRPr lang="en-US" sz="1400" b="1" dirty="0"/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1569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2220978"/>
              </p:ext>
            </p:extLst>
          </p:nvPr>
        </p:nvGraphicFramePr>
        <p:xfrm>
          <a:off x="323528" y="364502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3870297"/>
              </p:ext>
            </p:extLst>
          </p:nvPr>
        </p:nvGraphicFramePr>
        <p:xfrm>
          <a:off x="4427984" y="476672"/>
          <a:ext cx="4572000" cy="3096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9107509"/>
              </p:ext>
            </p:extLst>
          </p:nvPr>
        </p:nvGraphicFramePr>
        <p:xfrm>
          <a:off x="323528" y="260648"/>
          <a:ext cx="4572000" cy="3168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00562" y="43834"/>
            <a:ext cx="33913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imentary</a:t>
            </a:r>
            <a:r>
              <a:rPr lang="sv-S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51520" y="692696"/>
            <a:ext cx="675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520" y="3501008"/>
            <a:ext cx="675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6"/>
          <p:cNvSpPr txBox="1"/>
          <p:nvPr/>
        </p:nvSpPr>
        <p:spPr>
          <a:xfrm>
            <a:off x="4772283" y="382388"/>
            <a:ext cx="675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sv-S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22F30-20FF-4366-BC9A-8B8CB3F3161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378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05</Words>
  <Application>Microsoft Office PowerPoint</Application>
  <PresentationFormat>On-screen Show (4:3)</PresentationFormat>
  <Paragraphs>83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ran</dc:creator>
  <cp:lastModifiedBy>Kiran</cp:lastModifiedBy>
  <cp:revision>2</cp:revision>
  <dcterms:created xsi:type="dcterms:W3CDTF">2014-07-14T20:09:28Z</dcterms:created>
  <dcterms:modified xsi:type="dcterms:W3CDTF">2014-11-03T21:35:20Z</dcterms:modified>
</cp:coreProperties>
</file>